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292" userDrawn="1">
          <p15:clr>
            <a:srgbClr val="A4A3A4"/>
          </p15:clr>
        </p15:guide>
        <p15:guide id="2" pos="550" userDrawn="1">
          <p15:clr>
            <a:srgbClr val="A4A3A4"/>
          </p15:clr>
        </p15:guide>
        <p15:guide id="3" pos="890" userDrawn="1">
          <p15:clr>
            <a:srgbClr val="A4A3A4"/>
          </p15:clr>
        </p15:guide>
        <p15:guide id="4" orient="horz" pos="363" userDrawn="1">
          <p15:clr>
            <a:srgbClr val="A4A3A4"/>
          </p15:clr>
        </p15:guide>
        <p15:guide id="5" pos="123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84" d="100"/>
          <a:sy n="84" d="100"/>
        </p:scale>
        <p:origin x="2892" y="84"/>
      </p:cViewPr>
      <p:guideLst>
        <p:guide orient="horz" pos="1292"/>
        <p:guide pos="550"/>
        <p:guide pos="890"/>
        <p:guide orient="horz" pos="363"/>
        <p:guide pos="123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radchukv\AppData\Local\Microsoft\Windows\INetCache\Content.Outlook\M0LAYU64\&#1050;&#1086;&#1087;&#1080;&#1103;%20Osmotic%20pressure._ed_Stas(MpA)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radchukv\AppData\Local\Microsoft\Windows\INetCache\Content.Outlook\M0LAYU64\&#1050;&#1086;&#1087;&#1080;&#1103;%20Osmotic%20pressure._ed_Stas(MpA)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radchukv\AppData\Local\Microsoft\Windows\INetCache\Content.Outlook\M0LAYU64\&#1050;&#1086;&#1087;&#1080;&#1103;%20Osmotic%20pressure._ed_Stas(MpA)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/>
              <a:t>Growth medium</a:t>
            </a:r>
            <a:endParaRPr lang="uk-UA" sz="1200"/>
          </a:p>
        </c:rich>
      </c:tx>
      <c:layout>
        <c:manualLayout>
          <c:xMode val="edge"/>
          <c:yMode val="edge"/>
          <c:x val="0.39937733393081964"/>
          <c:y val="0.1269317750375542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371F-42CA-AC8B-3BFC8DC1DB98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371F-42CA-AC8B-3BFC8DC1DB98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371F-42CA-AC8B-3BFC8DC1DB98}"/>
              </c:ext>
            </c:extLst>
          </c:dPt>
          <c:errBars>
            <c:errBarType val="both"/>
            <c:errValType val="cust"/>
            <c:noEndCap val="0"/>
            <c:plus>
              <c:numRef>
                <c:f>Лист2!$C$93:$E$93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.8078E-2</c:v>
                  </c:pt>
                  <c:pt idx="2">
                    <c:v>9.2300000000000004E-3</c:v>
                  </c:pt>
                </c:numCache>
              </c:numRef>
            </c:plus>
            <c:minus>
              <c:numRef>
                <c:f>Лист2!$C$93:$E$93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.8078E-2</c:v>
                  </c:pt>
                  <c:pt idx="2">
                    <c:v>9.2300000000000004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Лист2!$C$91:$E$91</c:f>
              <c:strCache>
                <c:ptCount val="3"/>
                <c:pt idx="0">
                  <c:v>Control</c:v>
                </c:pt>
                <c:pt idx="1">
                  <c:v>15% PEG6000</c:v>
                </c:pt>
                <c:pt idx="2">
                  <c:v>300 mM NaCl</c:v>
                </c:pt>
              </c:strCache>
            </c:strRef>
          </c:cat>
          <c:val>
            <c:numRef>
              <c:f>Лист2!$C$92:$E$92</c:f>
              <c:numCache>
                <c:formatCode>General</c:formatCode>
                <c:ptCount val="3"/>
                <c:pt idx="0">
                  <c:v>-2.0999999999999999E-3</c:v>
                </c:pt>
                <c:pt idx="1">
                  <c:v>-0.28093000000000001</c:v>
                </c:pt>
                <c:pt idx="2">
                  <c:v>-1.31322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71F-42CA-AC8B-3BFC8DC1DB9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94810848"/>
        <c:axId val="194811264"/>
      </c:barChart>
      <c:catAx>
        <c:axId val="19481084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94811264"/>
        <c:crosses val="autoZero"/>
        <c:auto val="1"/>
        <c:lblAlgn val="ctr"/>
        <c:lblOffset val="100"/>
        <c:noMultiLvlLbl val="0"/>
      </c:catAx>
      <c:valAx>
        <c:axId val="19481126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dirty="0"/>
                  <a:t>MPa</a:t>
                </a:r>
                <a:endParaRPr lang="uk-UA" dirty="0"/>
              </a:p>
            </c:rich>
          </c:tx>
          <c:layout>
            <c:manualLayout>
              <c:xMode val="edge"/>
              <c:yMode val="edge"/>
              <c:x val="0.10298102981029811"/>
              <c:y val="0.4967854647099930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194810848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 i="1"/>
              <a:t>H. marinum</a:t>
            </a:r>
          </a:p>
        </c:rich>
      </c:tx>
      <c:layout>
        <c:manualLayout>
          <c:xMode val="edge"/>
          <c:yMode val="edge"/>
          <c:x val="0.50177921451690677"/>
          <c:y val="0.1327742837176799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76A4-4BE4-B0CE-7E10EA31EE4F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76A4-4BE4-B0CE-7E10EA31EE4F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76A4-4BE4-B0CE-7E10EA31EE4F}"/>
              </c:ext>
            </c:extLst>
          </c:dPt>
          <c:errBars>
            <c:errBarType val="both"/>
            <c:errValType val="cust"/>
            <c:noEndCap val="0"/>
            <c:plus>
              <c:numRef>
                <c:f>Лист2!$C$41:$E$41</c:f>
                <c:numCache>
                  <c:formatCode>General</c:formatCode>
                  <c:ptCount val="3"/>
                  <c:pt idx="0">
                    <c:v>0.08</c:v>
                  </c:pt>
                  <c:pt idx="1">
                    <c:v>6.6879999999999995E-2</c:v>
                  </c:pt>
                  <c:pt idx="2">
                    <c:v>0.88160000000000005</c:v>
                  </c:pt>
                </c:numCache>
              </c:numRef>
            </c:plus>
            <c:minus>
              <c:numRef>
                <c:f>Лист2!$C$41:$E$41</c:f>
                <c:numCache>
                  <c:formatCode>General</c:formatCode>
                  <c:ptCount val="3"/>
                  <c:pt idx="0">
                    <c:v>0.08</c:v>
                  </c:pt>
                  <c:pt idx="1">
                    <c:v>6.6879999999999995E-2</c:v>
                  </c:pt>
                  <c:pt idx="2">
                    <c:v>0.8816000000000000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Лист2!$C$39:$E$39</c:f>
              <c:strCache>
                <c:ptCount val="3"/>
                <c:pt idx="0">
                  <c:v>Control</c:v>
                </c:pt>
                <c:pt idx="1">
                  <c:v>15% PEG6000</c:v>
                </c:pt>
                <c:pt idx="2">
                  <c:v>300 mM NaCl</c:v>
                </c:pt>
              </c:strCache>
            </c:strRef>
          </c:cat>
          <c:val>
            <c:numRef>
              <c:f>Лист2!$C$40:$E$40</c:f>
              <c:numCache>
                <c:formatCode>0.00</c:formatCode>
                <c:ptCount val="3"/>
                <c:pt idx="0">
                  <c:v>-1.22</c:v>
                </c:pt>
                <c:pt idx="1">
                  <c:v>-1.4577</c:v>
                </c:pt>
                <c:pt idx="2">
                  <c:v>-8.36330000000000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6A4-4BE4-B0CE-7E10EA31EE4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28115439"/>
        <c:axId val="328116687"/>
      </c:barChart>
      <c:catAx>
        <c:axId val="32811543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328116687"/>
        <c:crosses val="autoZero"/>
        <c:auto val="1"/>
        <c:lblAlgn val="ctr"/>
        <c:lblOffset val="100"/>
        <c:noMultiLvlLbl val="0"/>
      </c:catAx>
      <c:valAx>
        <c:axId val="328116687"/>
        <c:scaling>
          <c:orientation val="minMax"/>
          <c:min val="-1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MPa</a:t>
                </a:r>
                <a:endParaRPr lang="uk-UA" dirty="0"/>
              </a:p>
            </c:rich>
          </c:tx>
          <c:layout>
            <c:manualLayout>
              <c:xMode val="edge"/>
              <c:yMode val="edge"/>
              <c:x val="9.7286304765375919E-2"/>
              <c:y val="0.4915619824251527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0.0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328115439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 i="1"/>
              <a:t>H. vulgare </a:t>
            </a:r>
            <a:endParaRPr lang="uk-UA" sz="1200" i="1"/>
          </a:p>
        </c:rich>
      </c:tx>
      <c:layout>
        <c:manualLayout>
          <c:xMode val="edge"/>
          <c:yMode val="edge"/>
          <c:x val="0.49771963804495251"/>
          <c:y val="0.131460297022620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5FC-47A2-8E8A-1527F61CB13E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15FC-47A2-8E8A-1527F61CB13E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5FC-47A2-8E8A-1527F61CB13E}"/>
              </c:ext>
            </c:extLst>
          </c:dPt>
          <c:errBars>
            <c:errBarType val="both"/>
            <c:errValType val="cust"/>
            <c:noEndCap val="0"/>
            <c:plus>
              <c:numRef>
                <c:f>Лист2!$C$45:$E$45</c:f>
                <c:numCache>
                  <c:formatCode>General</c:formatCode>
                  <c:ptCount val="3"/>
                  <c:pt idx="0">
                    <c:v>0.1583</c:v>
                  </c:pt>
                  <c:pt idx="1">
                    <c:v>0.12499</c:v>
                  </c:pt>
                  <c:pt idx="2">
                    <c:v>0.51400000000000001</c:v>
                  </c:pt>
                </c:numCache>
              </c:numRef>
            </c:plus>
            <c:minus>
              <c:numRef>
                <c:f>Лист2!$C$45:$E$45</c:f>
                <c:numCache>
                  <c:formatCode>General</c:formatCode>
                  <c:ptCount val="3"/>
                  <c:pt idx="0">
                    <c:v>0.1583</c:v>
                  </c:pt>
                  <c:pt idx="1">
                    <c:v>0.12499</c:v>
                  </c:pt>
                  <c:pt idx="2">
                    <c:v>0.514000000000000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Лист2!$C$43:$E$43</c:f>
              <c:strCache>
                <c:ptCount val="3"/>
                <c:pt idx="0">
                  <c:v>Control</c:v>
                </c:pt>
                <c:pt idx="1">
                  <c:v>15% PEG6000</c:v>
                </c:pt>
                <c:pt idx="2">
                  <c:v>300 mM NaCl</c:v>
                </c:pt>
              </c:strCache>
            </c:strRef>
          </c:cat>
          <c:val>
            <c:numRef>
              <c:f>Лист2!$C$44:$E$44</c:f>
              <c:numCache>
                <c:formatCode>0.00</c:formatCode>
                <c:ptCount val="3"/>
                <c:pt idx="0">
                  <c:v>-1.27</c:v>
                </c:pt>
                <c:pt idx="1">
                  <c:v>-1.63</c:v>
                </c:pt>
                <c:pt idx="2">
                  <c:v>-7.6281999999999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5FC-47A2-8E8A-1527F61CB13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29427487"/>
        <c:axId val="329430815"/>
      </c:barChart>
      <c:catAx>
        <c:axId val="329427487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329430815"/>
        <c:crosses val="autoZero"/>
        <c:auto val="1"/>
        <c:lblAlgn val="ctr"/>
        <c:lblOffset val="100"/>
        <c:noMultiLvlLbl val="0"/>
      </c:catAx>
      <c:valAx>
        <c:axId val="329430815"/>
        <c:scaling>
          <c:orientation val="minMax"/>
          <c:min val="-1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MPa</a:t>
                </a:r>
                <a:endParaRPr lang="uk-UA" dirty="0"/>
              </a:p>
            </c:rich>
          </c:tx>
          <c:layout>
            <c:manualLayout>
              <c:xMode val="edge"/>
              <c:yMode val="edge"/>
              <c:x val="8.7045641105862659E-2"/>
              <c:y val="0.4915619824251527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0.0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329427487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D109B-3D14-4497-92E3-FE4FB1983A02}" type="datetimeFigureOut">
              <a:rPr lang="en-US" smtClean="0"/>
              <a:t>11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7171E-9051-4F60-8457-642B6B4530E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08928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D109B-3D14-4497-92E3-FE4FB1983A02}" type="datetimeFigureOut">
              <a:rPr lang="en-US" smtClean="0"/>
              <a:t>11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7171E-9051-4F60-8457-642B6B4530E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62857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D109B-3D14-4497-92E3-FE4FB1983A02}" type="datetimeFigureOut">
              <a:rPr lang="en-US" smtClean="0"/>
              <a:t>11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7171E-9051-4F60-8457-642B6B4530E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88966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D109B-3D14-4497-92E3-FE4FB1983A02}" type="datetimeFigureOut">
              <a:rPr lang="en-US" smtClean="0"/>
              <a:t>11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7171E-9051-4F60-8457-642B6B4530E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99110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D109B-3D14-4497-92E3-FE4FB1983A02}" type="datetimeFigureOut">
              <a:rPr lang="en-US" smtClean="0"/>
              <a:t>11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7171E-9051-4F60-8457-642B6B4530E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96885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D109B-3D14-4497-92E3-FE4FB1983A02}" type="datetimeFigureOut">
              <a:rPr lang="en-US" smtClean="0"/>
              <a:t>11/1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7171E-9051-4F60-8457-642B6B4530E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72133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D109B-3D14-4497-92E3-FE4FB1983A02}" type="datetimeFigureOut">
              <a:rPr lang="en-US" smtClean="0"/>
              <a:t>11/1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7171E-9051-4F60-8457-642B6B4530E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84659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D109B-3D14-4497-92E3-FE4FB1983A02}" type="datetimeFigureOut">
              <a:rPr lang="en-US" smtClean="0"/>
              <a:t>11/1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7171E-9051-4F60-8457-642B6B4530E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77672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D109B-3D14-4497-92E3-FE4FB1983A02}" type="datetimeFigureOut">
              <a:rPr lang="en-US" smtClean="0"/>
              <a:t>11/1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7171E-9051-4F60-8457-642B6B4530E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04063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D109B-3D14-4497-92E3-FE4FB1983A02}" type="datetimeFigureOut">
              <a:rPr lang="en-US" smtClean="0"/>
              <a:t>11/1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7171E-9051-4F60-8457-642B6B4530E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39170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D109B-3D14-4497-92E3-FE4FB1983A02}" type="datetimeFigureOut">
              <a:rPr lang="en-US" smtClean="0"/>
              <a:t>11/1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7171E-9051-4F60-8457-642B6B4530E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30628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9D109B-3D14-4497-92E3-FE4FB1983A02}" type="datetimeFigureOut">
              <a:rPr lang="en-US" smtClean="0"/>
              <a:t>11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67171E-9051-4F60-8457-642B6B4530E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25784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Диаграмма 8">
            <a:extLst>
              <a:ext uri="{FF2B5EF4-FFF2-40B4-BE49-F238E27FC236}">
                <a16:creationId xmlns:a16="http://schemas.microsoft.com/office/drawing/2014/main" id="{00000000-0008-0000-0100-000009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87375425"/>
              </p:ext>
            </p:extLst>
          </p:nvPr>
        </p:nvGraphicFramePr>
        <p:xfrm>
          <a:off x="0" y="251460"/>
          <a:ext cx="2343150" cy="18173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feld 5">
            <a:extLst>
              <a:ext uri="{FF2B5EF4-FFF2-40B4-BE49-F238E27FC236}">
                <a16:creationId xmlns:a16="http://schemas.microsoft.com/office/drawing/2014/main" id="{664BF054-DC60-42E8-B2F3-44DCA91BA3F4}"/>
              </a:ext>
            </a:extLst>
          </p:cNvPr>
          <p:cNvSpPr txBox="1"/>
          <p:nvPr/>
        </p:nvSpPr>
        <p:spPr>
          <a:xfrm>
            <a:off x="256614" y="2417578"/>
            <a:ext cx="620731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Palatino Linotype" panose="02040502050505030304" pitchFamily="18" charset="0"/>
              </a:rPr>
              <a:t>Figure S1</a:t>
            </a:r>
            <a:r>
              <a:rPr lang="en-US" sz="1200" dirty="0">
                <a:latin typeface="Palatino Linotype" panose="02040502050505030304" pitchFamily="18" charset="0"/>
              </a:rPr>
              <a:t>. </a:t>
            </a:r>
            <a:r>
              <a:rPr lang="en-US" altLang="en-US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Osmotic potential of incubation media (</a:t>
            </a:r>
            <a:r>
              <a:rPr lang="en-US" altLang="en-US" sz="12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A</a:t>
            </a:r>
            <a:r>
              <a:rPr lang="en-US" altLang="en-US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) and in tissue sap samples derived from squeezed whole </a:t>
            </a:r>
            <a:r>
              <a:rPr lang="en-US" altLang="en-US" sz="1200" i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H. marinum </a:t>
            </a:r>
            <a:r>
              <a:rPr lang="en-US" altLang="en-US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(</a:t>
            </a:r>
            <a:r>
              <a:rPr lang="en-US" altLang="en-US" sz="12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B</a:t>
            </a:r>
            <a:r>
              <a:rPr lang="en-US" altLang="en-US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) and </a:t>
            </a:r>
            <a:r>
              <a:rPr lang="en-US" altLang="en-US" sz="1200" i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H. vulgare </a:t>
            </a:r>
            <a:r>
              <a:rPr lang="en-US" altLang="en-US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(</a:t>
            </a:r>
            <a:r>
              <a:rPr lang="en-US" altLang="en-US" sz="12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C</a:t>
            </a:r>
            <a:r>
              <a:rPr lang="en-US" altLang="en-US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) plants under osmotic (OST) and salinity (SST) stress as compared to control conditions (co). Data are mean ± SD; n = 8, t significant at: **, P &lt; 0.01 and ***, P &lt; 0.001. </a:t>
            </a:r>
            <a:endParaRPr lang="en-US" sz="1200" dirty="0">
              <a:latin typeface="Palatino Linotype" panose="02040502050505030304" pitchFamily="18" charset="0"/>
            </a:endParaRPr>
          </a:p>
        </p:txBody>
      </p:sp>
      <p:graphicFrame>
        <p:nvGraphicFramePr>
          <p:cNvPr id="7" name="Диаграмма 5">
            <a:extLst>
              <a:ext uri="{FF2B5EF4-FFF2-40B4-BE49-F238E27FC236}">
                <a16:creationId xmlns:a16="http://schemas.microsoft.com/office/drawing/2014/main" id="{00000000-0008-0000-0100-000006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07973812"/>
              </p:ext>
            </p:extLst>
          </p:nvPr>
        </p:nvGraphicFramePr>
        <p:xfrm>
          <a:off x="1988822" y="251460"/>
          <a:ext cx="2480308" cy="18173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Диаграмма 6">
            <a:extLst>
              <a:ext uri="{FF2B5EF4-FFF2-40B4-BE49-F238E27FC236}">
                <a16:creationId xmlns:a16="http://schemas.microsoft.com/office/drawing/2014/main" id="{00000000-0008-0000-0100-000007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58375136"/>
              </p:ext>
            </p:extLst>
          </p:nvPr>
        </p:nvGraphicFramePr>
        <p:xfrm>
          <a:off x="4149056" y="251460"/>
          <a:ext cx="2480308" cy="18173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9" name="Textfeld 26">
            <a:extLst>
              <a:ext uri="{FF2B5EF4-FFF2-40B4-BE49-F238E27FC236}">
                <a16:creationId xmlns:a16="http://schemas.microsoft.com/office/drawing/2014/main" id="{F20E8003-D453-4DE8-AE7C-4F038603A90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6614" y="339725"/>
            <a:ext cx="4191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de-DE" altLang="en-US" sz="1400" b="1" dirty="0">
                <a:latin typeface="+mn-lt"/>
              </a:rPr>
              <a:t>A</a:t>
            </a:r>
          </a:p>
        </p:txBody>
      </p:sp>
      <p:sp>
        <p:nvSpPr>
          <p:cNvPr id="10" name="Textfeld 7">
            <a:extLst>
              <a:ext uri="{FF2B5EF4-FFF2-40B4-BE49-F238E27FC236}">
                <a16:creationId xmlns:a16="http://schemas.microsoft.com/office/drawing/2014/main" id="{1488AA12-3478-4DC9-AB18-C4935CE81C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10787" y="1881396"/>
            <a:ext cx="483675" cy="2425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GB" altLang="en-US" sz="1200" dirty="0"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SST</a:t>
            </a:r>
          </a:p>
        </p:txBody>
      </p:sp>
      <p:sp>
        <p:nvSpPr>
          <p:cNvPr id="11" name="Textfeld 7">
            <a:extLst>
              <a:ext uri="{FF2B5EF4-FFF2-40B4-BE49-F238E27FC236}">
                <a16:creationId xmlns:a16="http://schemas.microsoft.com/office/drawing/2014/main" id="{B31F971C-7F64-4543-9F96-3F24C0BC92D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75714" y="1864181"/>
            <a:ext cx="39482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GB" altLang="en-US" sz="1200" dirty="0"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co </a:t>
            </a:r>
          </a:p>
        </p:txBody>
      </p:sp>
      <p:sp>
        <p:nvSpPr>
          <p:cNvPr id="12" name="Textfeld 7">
            <a:extLst>
              <a:ext uri="{FF2B5EF4-FFF2-40B4-BE49-F238E27FC236}">
                <a16:creationId xmlns:a16="http://schemas.microsoft.com/office/drawing/2014/main" id="{267D7458-D636-4B76-AB88-AFAD4E8CF35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71575" y="1881396"/>
            <a:ext cx="492968" cy="2425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GB" altLang="en-US" sz="1200" dirty="0"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OST</a:t>
            </a:r>
          </a:p>
        </p:txBody>
      </p:sp>
      <p:sp>
        <p:nvSpPr>
          <p:cNvPr id="13" name="Textfeld 7">
            <a:extLst>
              <a:ext uri="{FF2B5EF4-FFF2-40B4-BE49-F238E27FC236}">
                <a16:creationId xmlns:a16="http://schemas.microsoft.com/office/drawing/2014/main" id="{B5AF1A70-C347-4F5C-B504-C4C81804702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02479" y="1898313"/>
            <a:ext cx="483675" cy="2425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GB" altLang="en-US" sz="1200" dirty="0"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SST</a:t>
            </a:r>
          </a:p>
        </p:txBody>
      </p:sp>
      <p:sp>
        <p:nvSpPr>
          <p:cNvPr id="14" name="Textfeld 7">
            <a:extLst>
              <a:ext uri="{FF2B5EF4-FFF2-40B4-BE49-F238E27FC236}">
                <a16:creationId xmlns:a16="http://schemas.microsoft.com/office/drawing/2014/main" id="{6F2CE824-C423-42B3-BFB6-38D491C764B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67406" y="1881098"/>
            <a:ext cx="39482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GB" altLang="en-US" sz="1200" dirty="0"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co </a:t>
            </a:r>
          </a:p>
        </p:txBody>
      </p:sp>
      <p:sp>
        <p:nvSpPr>
          <p:cNvPr id="15" name="Textfeld 7">
            <a:extLst>
              <a:ext uri="{FF2B5EF4-FFF2-40B4-BE49-F238E27FC236}">
                <a16:creationId xmlns:a16="http://schemas.microsoft.com/office/drawing/2014/main" id="{D6B294F1-04D4-4FAA-A6DC-7C8D5CF7B70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63267" y="1898313"/>
            <a:ext cx="492968" cy="2425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GB" altLang="en-US" sz="1200" dirty="0"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OST</a:t>
            </a:r>
          </a:p>
        </p:txBody>
      </p:sp>
      <p:sp>
        <p:nvSpPr>
          <p:cNvPr id="16" name="Textfeld 7">
            <a:extLst>
              <a:ext uri="{FF2B5EF4-FFF2-40B4-BE49-F238E27FC236}">
                <a16:creationId xmlns:a16="http://schemas.microsoft.com/office/drawing/2014/main" id="{E81BD526-3541-4CC3-92C5-F30D2208350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80249" y="1881397"/>
            <a:ext cx="483675" cy="2425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GB" altLang="en-US" sz="1200" dirty="0"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SST</a:t>
            </a:r>
          </a:p>
        </p:txBody>
      </p:sp>
      <p:sp>
        <p:nvSpPr>
          <p:cNvPr id="17" name="Textfeld 7">
            <a:extLst>
              <a:ext uri="{FF2B5EF4-FFF2-40B4-BE49-F238E27FC236}">
                <a16:creationId xmlns:a16="http://schemas.microsoft.com/office/drawing/2014/main" id="{147634A8-80F3-4F82-A6A7-8617841508F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45176" y="1864182"/>
            <a:ext cx="39482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/>
            <a:r>
              <a:rPr lang="en-GB" altLang="en-US" sz="1200" dirty="0"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co </a:t>
            </a:r>
          </a:p>
        </p:txBody>
      </p:sp>
      <p:sp>
        <p:nvSpPr>
          <p:cNvPr id="18" name="Textfeld 7">
            <a:extLst>
              <a:ext uri="{FF2B5EF4-FFF2-40B4-BE49-F238E27FC236}">
                <a16:creationId xmlns:a16="http://schemas.microsoft.com/office/drawing/2014/main" id="{5EDA92A1-CD9A-440D-9C24-8F3F894488F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41037" y="1881397"/>
            <a:ext cx="492968" cy="2425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lnSpc>
                <a:spcPct val="80000"/>
              </a:lnSpc>
            </a:pPr>
            <a:r>
              <a:rPr lang="en-GB" altLang="en-US" sz="1200" dirty="0"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OST</a:t>
            </a:r>
          </a:p>
        </p:txBody>
      </p:sp>
      <p:sp>
        <p:nvSpPr>
          <p:cNvPr id="19" name="Textfeld 26">
            <a:extLst>
              <a:ext uri="{FF2B5EF4-FFF2-40B4-BE49-F238E27FC236}">
                <a16:creationId xmlns:a16="http://schemas.microsoft.com/office/drawing/2014/main" id="{A70B9124-F95C-46A3-B4E6-6579721560F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42368" y="339725"/>
            <a:ext cx="4191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de-DE" altLang="en-US" sz="1400" b="1" dirty="0">
                <a:latin typeface="+mn-lt"/>
              </a:rPr>
              <a:t>B</a:t>
            </a:r>
          </a:p>
        </p:txBody>
      </p:sp>
      <p:sp>
        <p:nvSpPr>
          <p:cNvPr id="20" name="Textfeld 26">
            <a:extLst>
              <a:ext uri="{FF2B5EF4-FFF2-40B4-BE49-F238E27FC236}">
                <a16:creationId xmlns:a16="http://schemas.microsoft.com/office/drawing/2014/main" id="{31CA62E6-3178-4F16-9F79-FB34162F432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33640" y="339724"/>
            <a:ext cx="4191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de-DE" altLang="en-US" sz="1400" b="1" dirty="0">
                <a:latin typeface="+mn-lt"/>
              </a:rPr>
              <a:t>C</a:t>
            </a: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6732BA17-CE74-4248-8550-C951AAF912AA}"/>
              </a:ext>
            </a:extLst>
          </p:cNvPr>
          <p:cNvSpPr txBox="1"/>
          <p:nvPr/>
        </p:nvSpPr>
        <p:spPr>
          <a:xfrm>
            <a:off x="3352549" y="860286"/>
            <a:ext cx="4229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Palatino Linotype" panose="02040502050505030304" pitchFamily="18" charset="0"/>
              </a:rPr>
              <a:t>***</a:t>
            </a: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D2DEA264-2471-480D-8319-5DE28697AE69}"/>
              </a:ext>
            </a:extLst>
          </p:cNvPr>
          <p:cNvSpPr txBox="1"/>
          <p:nvPr/>
        </p:nvSpPr>
        <p:spPr>
          <a:xfrm>
            <a:off x="3894392" y="1768821"/>
            <a:ext cx="4229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Palatino Linotype" panose="02040502050505030304" pitchFamily="18" charset="0"/>
              </a:rPr>
              <a:t>***</a:t>
            </a: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422460CD-9353-49D6-AB23-41ADE9AC174C}"/>
              </a:ext>
            </a:extLst>
          </p:cNvPr>
          <p:cNvSpPr txBox="1"/>
          <p:nvPr/>
        </p:nvSpPr>
        <p:spPr>
          <a:xfrm>
            <a:off x="6063434" y="1670259"/>
            <a:ext cx="4229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Palatino Linotype" panose="02040502050505030304" pitchFamily="18" charset="0"/>
              </a:rPr>
              <a:t>***</a:t>
            </a: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80D6D5A8-05CB-4635-BD5F-B63498EAB31E}"/>
              </a:ext>
            </a:extLst>
          </p:cNvPr>
          <p:cNvSpPr txBox="1"/>
          <p:nvPr/>
        </p:nvSpPr>
        <p:spPr>
          <a:xfrm>
            <a:off x="5550468" y="870779"/>
            <a:ext cx="3948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Palatino Linotype" panose="02040502050505030304" pitchFamily="18" charset="0"/>
              </a:rPr>
              <a:t>**</a:t>
            </a:r>
          </a:p>
        </p:txBody>
      </p:sp>
    </p:spTree>
    <p:extLst>
      <p:ext uri="{BB962C8B-B14F-4D97-AF65-F5344CB8AC3E}">
        <p14:creationId xmlns:p14="http://schemas.microsoft.com/office/powerpoint/2010/main" val="42564875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04</Words>
  <Application>Microsoft Office PowerPoint</Application>
  <PresentationFormat>Bildschirmpräsentation (4:3)</PresentationFormat>
  <Paragraphs>23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imes New Roman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Volodymyr Radchuk</dc:creator>
  <cp:lastModifiedBy>Volodymyr Radchuk</cp:lastModifiedBy>
  <cp:revision>8</cp:revision>
  <dcterms:created xsi:type="dcterms:W3CDTF">2020-10-28T10:12:47Z</dcterms:created>
  <dcterms:modified xsi:type="dcterms:W3CDTF">2020-11-11T07:50:52Z</dcterms:modified>
</cp:coreProperties>
</file>